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772400" cy="100584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0A0D2F-E34B-4E89-B2F6-F317752F7D3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4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82480" y="2905200"/>
            <a:ext cx="6607440" cy="28789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82480" y="6058080"/>
            <a:ext cx="6607440" cy="28789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581C73-860E-481C-A603-7433A9718D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4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82480" y="290520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968280" y="290520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82480" y="605808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968280" y="605808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3A3D55-EE6A-41A0-AC48-6340E805F7F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4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82480" y="2905200"/>
            <a:ext cx="2127240" cy="28789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816640" y="2905200"/>
            <a:ext cx="2127240" cy="28789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050440" y="2905200"/>
            <a:ext cx="2127240" cy="28789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82480" y="6058080"/>
            <a:ext cx="2127240" cy="28789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816640" y="6058080"/>
            <a:ext cx="2127240" cy="28789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050440" y="6058080"/>
            <a:ext cx="2127240" cy="28789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C817E2-399A-46C1-A3CB-A39336D007B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4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82480" y="2905200"/>
            <a:ext cx="6607440" cy="603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901"/>
              </a:spcBef>
              <a:buNone/>
              <a:tabLst>
                <a:tab algn="l" pos="0"/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9E5AAC-E795-453C-BC9B-11000C5F2AD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4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82480" y="2905200"/>
            <a:ext cx="6607440" cy="60357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689E7F-7BA6-4797-9979-94CDAE13A3E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4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82480" y="2905200"/>
            <a:ext cx="3224160" cy="60357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968280" y="2905200"/>
            <a:ext cx="3224160" cy="60357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89102A-694C-4677-9089-8E96E20E4F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4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C4A0F7-BBA5-4B83-B400-2140B63F316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82480" y="893880"/>
            <a:ext cx="6607440" cy="7770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901"/>
              </a:spcBef>
              <a:tabLst>
                <a:tab algn="l" pos="0"/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F743A4-793F-400F-B7DA-66193AC3B0A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4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82480" y="290520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968280" y="2905200"/>
            <a:ext cx="3224160" cy="60357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82480" y="605808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62F53B-C11F-4A94-98F4-C85FDA100B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4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82480" y="2905200"/>
            <a:ext cx="3224160" cy="60357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968280" y="290520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968280" y="605808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40071B-693B-4914-9A7B-5A5BB2959B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4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82480" y="290520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968280" y="290520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82480" y="6058080"/>
            <a:ext cx="6607440" cy="28789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9D28CD-A817-42F2-8D53-DB249516E3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r>
              <a:rPr b="0" lang="en-US" sz="4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82480" y="2905200"/>
            <a:ext cx="6607440" cy="60357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marL="382680" indent="-382680">
              <a:spcBef>
                <a:spcPts val="901"/>
              </a:spcBef>
              <a:buClr>
                <a:srgbClr val="000000"/>
              </a:buClr>
              <a:buFont typeface="Arial"/>
              <a:buChar char="•"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lvl="1" marL="826920" indent="-317160">
              <a:spcBef>
                <a:spcPts val="901"/>
              </a:spcBef>
              <a:buClr>
                <a:srgbClr val="000000"/>
              </a:buClr>
              <a:buFont typeface="Arial"/>
              <a:buChar char="–"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lvl="2" marL="1273320" indent="-254160">
              <a:spcBef>
                <a:spcPts val="901"/>
              </a:spcBef>
              <a:buClr>
                <a:srgbClr val="000000"/>
              </a:buClr>
              <a:buFont typeface="Arial"/>
              <a:buChar char="•"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lvl="3" marL="1782720" indent="-253800">
              <a:spcBef>
                <a:spcPts val="901"/>
              </a:spcBef>
              <a:buClr>
                <a:srgbClr val="000000"/>
              </a:buClr>
              <a:buFont typeface="Arial"/>
              <a:buChar char="–"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lvl="4" marL="2292480" indent="-254160">
              <a:spcBef>
                <a:spcPts val="901"/>
              </a:spcBef>
              <a:buClr>
                <a:srgbClr val="000000"/>
              </a:buClr>
              <a:buFont typeface="Arial"/>
              <a:buChar char="»"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lvl="5" marL="2292480" indent="-254160">
              <a:spcBef>
                <a:spcPts val="901"/>
              </a:spcBef>
              <a:buClr>
                <a:srgbClr val="000000"/>
              </a:buClr>
              <a:buFont typeface="Arial"/>
              <a:buChar char="»"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lvl="6" marL="2292480" indent="-254160">
              <a:spcBef>
                <a:spcPts val="901"/>
              </a:spcBef>
              <a:buClr>
                <a:srgbClr val="000000"/>
              </a:buClr>
              <a:buFont typeface="Arial"/>
              <a:buChar char="»"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82480" y="9164160"/>
            <a:ext cx="1619280" cy="6699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655720" y="9164160"/>
            <a:ext cx="2460960" cy="6699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570640" y="9164160"/>
            <a:ext cx="1619280" cy="6699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6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AD28579-8148-4E95-9EB9-FC23942EF435}" type="slidenum">
              <a:rPr b="0" lang="en-US" sz="16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380880" y="1523880"/>
          <a:ext cx="7010640" cy="7101000"/>
        </p:xfrm>
        <a:graphic>
          <a:graphicData uri="http://schemas.openxmlformats.org/drawingml/2006/table">
            <a:tbl>
              <a:tblPr/>
              <a:tblGrid>
                <a:gridCol w="1540080"/>
                <a:gridCol w="974520"/>
                <a:gridCol w="487440"/>
                <a:gridCol w="488880"/>
                <a:gridCol w="490680"/>
                <a:gridCol w="485640"/>
                <a:gridCol w="569880"/>
                <a:gridCol w="561960"/>
                <a:gridCol w="476280"/>
                <a:gridCol w="390600"/>
                <a:gridCol w="544680"/>
              </a:tblGrid>
              <a:tr h="771480"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enotyp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          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ATE, 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rk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7400"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A cat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</a:tr>
              <a:tr h="252360"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A dat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</a:tr>
              <a:tr h="254160"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Ch unc-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52360"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Ch gar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53800"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md-3(0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A cat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</a:tr>
              <a:tr h="252360"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A dat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1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</a:tr>
              <a:tr h="252720"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Ch unc-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53800"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Ch gar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52360"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b-23(0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A cat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</a:tr>
              <a:tr h="252360"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A dat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5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8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</a:tr>
              <a:tr h="254160"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Ch unc-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52360"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Ch gar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54160"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md-3(0) mab-23(0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A cat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</a:tr>
              <a:tr h="252360"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A dat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5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</a:tr>
              <a:tr h="252360"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Ch unc-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5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53800"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st-1(lf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A cat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</a:tr>
              <a:tr h="252720"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A dat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</a:tr>
              <a:tr h="252360"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Ch unc-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53800"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st-1(RNAi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A cat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</a:tr>
              <a:tr h="252360"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ntrol for 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NA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A cat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</a:tr>
              <a:tr h="254160"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st-1(RNAi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Ch unc-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52360"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ntrol for </a:t>
                      </a: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NA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Ch unc-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52360"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st-1(RNAi); dmd-3(0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Ch unc-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0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54160"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st-1(lf); dmd-3(0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A cat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</a:tr>
              <a:tr h="252360"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st-1(lf); mab-23(0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A cat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  <a:tc>
                  <a:txBody>
                    <a:bodyPr lIns="103680" rIns="103680" tIns="50400" bIns="50400" anchor="t">
                      <a:noAutofit/>
                    </a:bodyPr>
                    <a:p>
                      <a:pPr algn="r">
                        <a:spcBef>
                          <a:spcPts val="249"/>
                        </a:spcBef>
                        <a:tabLst>
                          <a:tab algn="l" pos="0"/>
                          <a:tab algn="l" pos="1019160"/>
                          <a:tab algn="l" pos="2038320"/>
                          <a:tab algn="l" pos="3057480"/>
                          <a:tab algn="l" pos="4076640"/>
                          <a:tab algn="l" pos="5095800"/>
                          <a:tab algn="l" pos="6114960"/>
                          <a:tab algn="l" pos="7134120"/>
                          <a:tab algn="l" pos="8153280"/>
                          <a:tab algn="l" pos="9172440"/>
                          <a:tab algn="l" pos="101916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03680" marR="103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6e6e6"/>
                    </a:solidFill>
                  </a:tcPr>
                </a:tc>
              </a:tr>
            </a:tbl>
          </a:graphicData>
        </a:graphic>
      </p:graphicFrame>
      <p:sp>
        <p:nvSpPr>
          <p:cNvPr id="42" name="Rectangle 34"/>
          <p:cNvSpPr/>
          <p:nvPr/>
        </p:nvSpPr>
        <p:spPr>
          <a:xfrm>
            <a:off x="3429000" y="9296280"/>
            <a:ext cx="871560" cy="28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01880" rIns="101880" tIns="51120" bIns="5112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able S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2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12T02:55:07Z</dcterms:created>
  <dc:creator>Robyn Lints</dc:creator>
  <dc:description/>
  <dc:language>en-US</dc:language>
  <cp:lastModifiedBy>Robyn Lints</cp:lastModifiedBy>
  <cp:lastPrinted>2011-09-12T14:48:40Z</cp:lastPrinted>
  <dcterms:modified xsi:type="dcterms:W3CDTF">2011-10-07T14:37:20Z</dcterms:modified>
  <cp:revision>231</cp:revision>
  <dc:subject/>
  <dc:title>PowerPoint Presentation</dc:title>
</cp:coreProperties>
</file>